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756"/>
    <p:restoredTop sz="94709"/>
  </p:normalViewPr>
  <p:slideViewPr>
    <p:cSldViewPr snapToGrid="0">
      <p:cViewPr varScale="1">
        <p:scale>
          <a:sx n="102" d="100"/>
          <a:sy n="102" d="100"/>
        </p:scale>
        <p:origin x="61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7837034-BB5E-8CE8-183B-D37DEB3EACF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E0FDD05-D1D7-F335-2A69-ECAD81A205B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D3222F8-81C4-96AA-BB15-7D0310D770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E93A3-72A3-2342-9C89-993EA9F45C54}" type="datetimeFigureOut">
              <a:rPr kumimoji="1" lang="ja-JP" altLang="en-US" smtClean="0"/>
              <a:t>2025/5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3DB0360-B884-4802-7EFF-647AB2B574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6DC91D8-C9FB-34E0-B804-9597C83BCC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9D0292-C96F-1A48-A0D7-43DB65504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63371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7A3A401-D358-E6B8-9BA5-524B8EF92F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AFB3E07-83A0-B7EB-A30F-047294CA89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4D22F97-09A6-661E-3CAF-B93AFCDAD4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E93A3-72A3-2342-9C89-993EA9F45C54}" type="datetimeFigureOut">
              <a:rPr kumimoji="1" lang="ja-JP" altLang="en-US" smtClean="0"/>
              <a:t>2025/5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76B6C2F-5F65-DB46-A6B0-F6E5B96F0C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A488D3D-FAF4-DACF-A870-2A236F2F6B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9D0292-C96F-1A48-A0D7-43DB65504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03893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5302B32-E846-6FC0-F5A3-428629E57FF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97CF887-E01B-77A4-055E-43C82BEF8C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A026CB3-DA16-2DFF-FA4A-E741F7BD3E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E93A3-72A3-2342-9C89-993EA9F45C54}" type="datetimeFigureOut">
              <a:rPr kumimoji="1" lang="ja-JP" altLang="en-US" smtClean="0"/>
              <a:t>2025/5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A1F4B0B-837E-9E50-C390-D7762DD35C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410FCF3-CBF7-7254-AE75-1D1548C18B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9D0292-C96F-1A48-A0D7-43DB65504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97060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9602F9B-540A-E437-45FD-92F8355B78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ECC6BD4-512D-BA50-21E2-7B68ED50194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2A6A74E-E5F3-A0E7-5E94-74B8557A8E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E93A3-72A3-2342-9C89-993EA9F45C54}" type="datetimeFigureOut">
              <a:rPr kumimoji="1" lang="ja-JP" altLang="en-US" smtClean="0"/>
              <a:t>2025/5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15EE2BF-37DA-4666-2718-0445C62ABF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8CEFE02-DEEF-17DC-3F96-E243746922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9D0292-C96F-1A48-A0D7-43DB65504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70642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7C2076F-7AB9-1AEB-1E04-CE0394C176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753D227-92D7-78F4-F162-2A6AEEEBA7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00A769B-9765-ADA7-1D9C-21C6F6D4BB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E93A3-72A3-2342-9C89-993EA9F45C54}" type="datetimeFigureOut">
              <a:rPr kumimoji="1" lang="ja-JP" altLang="en-US" smtClean="0"/>
              <a:t>2025/5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C0BB631-5C8D-89AC-7B10-CD7F833D8F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CA93026-5F7A-4D19-C2D8-5D6E5B15E2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9D0292-C96F-1A48-A0D7-43DB65504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0810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271E754-49E9-3A28-05B7-179E4C2F6B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1D0989C-3C52-072C-DBBB-1D9CF1DA5F1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1C4B1DC-37E3-BBDA-F431-5EFF1E97D7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D1B747B-C7CD-D640-2FA8-A4712F7C2F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E93A3-72A3-2342-9C89-993EA9F45C54}" type="datetimeFigureOut">
              <a:rPr kumimoji="1" lang="ja-JP" altLang="en-US" smtClean="0"/>
              <a:t>2025/5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472C842-5FC1-7ECB-DDFB-C93C89746A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CB27B4E-F070-BDA0-CA1C-F7531BC216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9D0292-C96F-1A48-A0D7-43DB65504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14693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48B8EB4-406B-5FA6-35E2-6DE5C10AFF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4323A25-D29B-FC44-3F0B-CB90ACAFA9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72E8C0A-FC7F-7DFA-A1DB-2893D25620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C75981AA-DC24-A352-DFFE-81BD995A65A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E60C49F-D24D-61BE-C7E3-FCACF5F6F51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49F5550-67F8-9F27-A6C4-4FDE3770FC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E93A3-72A3-2342-9C89-993EA9F45C54}" type="datetimeFigureOut">
              <a:rPr kumimoji="1" lang="ja-JP" altLang="en-US" smtClean="0"/>
              <a:t>2025/5/2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C64A040-C832-17B0-76A2-F3CAA44150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52AF6F41-A6B1-B0C6-7DBC-8013B3B48A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9D0292-C96F-1A48-A0D7-43DB65504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76013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E8BC037-F65C-E2BF-9A63-D85BB18785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9B569908-32F1-4F8F-8F87-6E6215C508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E93A3-72A3-2342-9C89-993EA9F45C54}" type="datetimeFigureOut">
              <a:rPr kumimoji="1" lang="ja-JP" altLang="en-US" smtClean="0"/>
              <a:t>2025/5/2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FDDB82F-7392-D38C-72D9-DB5CE9083D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EA3FDA7-B657-920D-D067-A41429EF04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9D0292-C96F-1A48-A0D7-43DB65504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0470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0BD7E616-9F5F-A8F8-4DBF-5ECEE4F98E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E93A3-72A3-2342-9C89-993EA9F45C54}" type="datetimeFigureOut">
              <a:rPr kumimoji="1" lang="ja-JP" altLang="en-US" smtClean="0"/>
              <a:t>2025/5/2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3E0AD06-009E-627C-2849-B09ECD682C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ADA4CDB-5A93-BA62-7245-13EDE0BB05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9D0292-C96F-1A48-A0D7-43DB65504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9110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690B70A-5C07-CA6F-25A3-E7E869C8EA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42290E4-CE57-A7B3-EBF6-37F8B9530E1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DB8CD38-4FD2-C055-63A5-5D8F3A61C5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EE87953-91F0-5A0F-2F6B-509F058232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E93A3-72A3-2342-9C89-993EA9F45C54}" type="datetimeFigureOut">
              <a:rPr kumimoji="1" lang="ja-JP" altLang="en-US" smtClean="0"/>
              <a:t>2025/5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BC05949-70A1-3A5E-7961-34D8765B45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E991D4E-0811-EBDE-752F-E7C9E98F49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9D0292-C96F-1A48-A0D7-43DB65504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17676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9C05021-8F99-F1B7-2D77-3189FCCD91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92C8993C-BDB4-877A-4F61-9A11D94B131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A1A2DE3-F80B-94E3-5D81-7AD1CC02F5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34E6303-6DE7-BD04-BD97-B0C3AED6F6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E93A3-72A3-2342-9C89-993EA9F45C54}" type="datetimeFigureOut">
              <a:rPr kumimoji="1" lang="ja-JP" altLang="en-US" smtClean="0"/>
              <a:t>2025/5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81386AA-4D5B-D9B5-D963-C10D7E1E79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774AAC8-49F6-4C48-7B00-BC5F52F077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9D0292-C96F-1A48-A0D7-43DB65504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43675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132EA4A7-3E67-D852-1A97-F30BEA99BF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2FD9A01-3126-3FCE-D4B8-565381D990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5A86F8F-9DA9-082A-8BB8-905416530F1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9E93A3-72A3-2342-9C89-993EA9F45C54}" type="datetimeFigureOut">
              <a:rPr kumimoji="1" lang="ja-JP" altLang="en-US" smtClean="0"/>
              <a:t>2025/5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4A8E678-9022-EA6F-C696-747E5CC9C8B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970C403-7D1B-F119-EC6F-076C1FD979F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9D0292-C96F-1A48-A0D7-43DB65504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889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53DFCBD-0815-450E-C1B6-4CE88AB354B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図 18">
            <a:extLst>
              <a:ext uri="{FF2B5EF4-FFF2-40B4-BE49-F238E27FC236}">
                <a16:creationId xmlns:a16="http://schemas.microsoft.com/office/drawing/2014/main" id="{42E003B7-9F93-65CA-08A1-AD68926722F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46085" y="824668"/>
            <a:ext cx="6964922" cy="4387790"/>
          </a:xfrm>
          <a:prstGeom prst="rect">
            <a:avLst/>
          </a:prstGeom>
        </p:spPr>
      </p:pic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C4A254A6-190F-AC36-90B4-5BA244ADFD04}"/>
              </a:ext>
            </a:extLst>
          </p:cNvPr>
          <p:cNvCxnSpPr/>
          <p:nvPr/>
        </p:nvCxnSpPr>
        <p:spPr>
          <a:xfrm>
            <a:off x="3732210" y="3783607"/>
            <a:ext cx="423081" cy="0"/>
          </a:xfrm>
          <a:prstGeom prst="line">
            <a:avLst/>
          </a:prstGeom>
          <a:ln w="127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id="{4EF19C4A-1EC3-5CBC-3DA1-7246A2441544}"/>
              </a:ext>
            </a:extLst>
          </p:cNvPr>
          <p:cNvCxnSpPr/>
          <p:nvPr/>
        </p:nvCxnSpPr>
        <p:spPr>
          <a:xfrm>
            <a:off x="3749252" y="4045191"/>
            <a:ext cx="423081" cy="0"/>
          </a:xfrm>
          <a:prstGeom prst="line">
            <a:avLst/>
          </a:prstGeom>
          <a:ln w="12700"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4DEE21FA-8143-9F69-9F20-196C4D8AFC4C}"/>
              </a:ext>
            </a:extLst>
          </p:cNvPr>
          <p:cNvCxnSpPr/>
          <p:nvPr/>
        </p:nvCxnSpPr>
        <p:spPr>
          <a:xfrm>
            <a:off x="3736726" y="4290851"/>
            <a:ext cx="423081" cy="0"/>
          </a:xfrm>
          <a:prstGeom prst="line">
            <a:avLst/>
          </a:prstGeom>
          <a:ln w="127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A898AC1E-CE81-84AD-5011-0948AE419C97}"/>
              </a:ext>
            </a:extLst>
          </p:cNvPr>
          <p:cNvCxnSpPr/>
          <p:nvPr/>
        </p:nvCxnSpPr>
        <p:spPr>
          <a:xfrm>
            <a:off x="3750374" y="4563806"/>
            <a:ext cx="423081" cy="0"/>
          </a:xfrm>
          <a:prstGeom prst="line">
            <a:avLst/>
          </a:prstGeom>
          <a:ln w="12700">
            <a:solidFill>
              <a:srgbClr val="C0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8EDF9947-4EC7-51BF-3B40-AB21358A88D8}"/>
              </a:ext>
            </a:extLst>
          </p:cNvPr>
          <p:cNvSpPr/>
          <p:nvPr/>
        </p:nvSpPr>
        <p:spPr>
          <a:xfrm>
            <a:off x="2079321" y="5198302"/>
            <a:ext cx="8242126" cy="12400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89DF174-64A6-347C-16E6-DBAEFFEAEE05}"/>
              </a:ext>
            </a:extLst>
          </p:cNvPr>
          <p:cNvSpPr txBox="1"/>
          <p:nvPr/>
        </p:nvSpPr>
        <p:spPr>
          <a:xfrm>
            <a:off x="1077687" y="4860099"/>
            <a:ext cx="225801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ar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risk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ND and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-positive SLN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CB0F03E-72E8-3A8C-9A16-9B7E14281A08}"/>
              </a:ext>
            </a:extLst>
          </p:cNvPr>
          <p:cNvSpPr txBox="1"/>
          <p:nvPr/>
        </p:nvSpPr>
        <p:spPr>
          <a:xfrm>
            <a:off x="3578119" y="3276277"/>
            <a:ext cx="5461348" cy="144417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  <a:tabLst>
                <a:tab pos="1149350" algn="l"/>
              </a:tabLst>
            </a:pP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5-year regional node recurrence-free survival rate (95% confidence interval)</a:t>
            </a:r>
          </a:p>
          <a:p>
            <a:pPr>
              <a:lnSpc>
                <a:spcPct val="150000"/>
              </a:lnSpc>
              <a:tabLst>
                <a:tab pos="1149350" algn="l"/>
              </a:tabLst>
            </a:pP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</a:t>
            </a:r>
            <a:r>
              <a:rPr lang="en-US" altLang="ja-JP" sz="1200" b="1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ND and 1-positive SLN	 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7.7% (93.9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% to 99.1%) </a:t>
            </a:r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tabLst>
                <a:tab pos="1149350" algn="l"/>
              </a:tabLst>
            </a:pPr>
            <a:r>
              <a:rPr lang="en-US" altLang="ja-JP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ALND and 2 or 3-positive SLNs	 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%  (100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% to 100%) </a:t>
            </a:r>
            <a:endParaRPr lang="en-US" altLang="ja-JP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tabLst>
                <a:tab pos="1149350" algn="l"/>
              </a:tabLst>
            </a:pPr>
            <a:r>
              <a:rPr lang="en-US" altLang="ja-JP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</a:t>
            </a:r>
            <a:r>
              <a:rPr lang="en-US" altLang="ja-JP" sz="1200" b="1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NB and 1-positive SLN	 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8.3% (94.8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% to 99.4%) </a:t>
            </a:r>
            <a:endParaRPr lang="en-US" altLang="ja-JP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tabLst>
                <a:tab pos="1149350" algn="l"/>
              </a:tabLst>
            </a:pPr>
            <a:r>
              <a:rPr lang="en-US" altLang="ja-JP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</a:t>
            </a:r>
            <a:r>
              <a:rPr lang="en-US" altLang="ja-JP" sz="120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NB and 2 or 3-postive SLNs	 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6.3% (76.5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% to 99.5%)   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D6C5A65-DF79-3541-559D-EFBC22483E94}"/>
              </a:ext>
            </a:extLst>
          </p:cNvPr>
          <p:cNvSpPr txBox="1"/>
          <p:nvPr/>
        </p:nvSpPr>
        <p:spPr>
          <a:xfrm>
            <a:off x="964505" y="364609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F5B109F3-EC68-F136-137C-2388EE0DDA64}"/>
              </a:ext>
            </a:extLst>
          </p:cNvPr>
          <p:cNvSpPr txBox="1"/>
          <p:nvPr/>
        </p:nvSpPr>
        <p:spPr>
          <a:xfrm>
            <a:off x="799428" y="5498255"/>
            <a:ext cx="25362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ND and 2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3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ositive SLN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193CB8D4-BBC5-6556-7416-A6AB923F5D94}"/>
              </a:ext>
            </a:extLst>
          </p:cNvPr>
          <p:cNvSpPr txBox="1"/>
          <p:nvPr/>
        </p:nvSpPr>
        <p:spPr>
          <a:xfrm>
            <a:off x="1213084" y="5756333"/>
            <a:ext cx="21259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NB and 1-positive SLN group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EEA0E390-95B6-67CA-1849-2AFBEFE033B9}"/>
              </a:ext>
            </a:extLst>
          </p:cNvPr>
          <p:cNvSpPr txBox="1"/>
          <p:nvPr/>
        </p:nvSpPr>
        <p:spPr>
          <a:xfrm>
            <a:off x="930058" y="6033332"/>
            <a:ext cx="2416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NB and 2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3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ositive SLN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</a:t>
            </a:r>
            <a:endParaRPr kumimoji="1" lang="ja-JP" altLang="en-US" sz="1200"/>
          </a:p>
        </p:txBody>
      </p:sp>
      <p:graphicFrame>
        <p:nvGraphicFramePr>
          <p:cNvPr id="13" name="表 12">
            <a:extLst>
              <a:ext uri="{FF2B5EF4-FFF2-40B4-BE49-F238E27FC236}">
                <a16:creationId xmlns:a16="http://schemas.microsoft.com/office/drawing/2014/main" id="{9FFDC04D-7A4A-EA8C-F241-7CBC2D9BD68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37598290"/>
              </p:ext>
            </p:extLst>
          </p:nvPr>
        </p:nvGraphicFramePr>
        <p:xfrm>
          <a:off x="3349108" y="5311388"/>
          <a:ext cx="6077918" cy="106167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52538">
                  <a:extLst>
                    <a:ext uri="{9D8B030D-6E8A-4147-A177-3AD203B41FA5}">
                      <a16:colId xmlns:a16="http://schemas.microsoft.com/office/drawing/2014/main" val="2458037181"/>
                    </a:ext>
                  </a:extLst>
                </a:gridCol>
                <a:gridCol w="552538">
                  <a:extLst>
                    <a:ext uri="{9D8B030D-6E8A-4147-A177-3AD203B41FA5}">
                      <a16:colId xmlns:a16="http://schemas.microsoft.com/office/drawing/2014/main" val="755539464"/>
                    </a:ext>
                  </a:extLst>
                </a:gridCol>
                <a:gridCol w="552538">
                  <a:extLst>
                    <a:ext uri="{9D8B030D-6E8A-4147-A177-3AD203B41FA5}">
                      <a16:colId xmlns:a16="http://schemas.microsoft.com/office/drawing/2014/main" val="587094623"/>
                    </a:ext>
                  </a:extLst>
                </a:gridCol>
                <a:gridCol w="552538">
                  <a:extLst>
                    <a:ext uri="{9D8B030D-6E8A-4147-A177-3AD203B41FA5}">
                      <a16:colId xmlns:a16="http://schemas.microsoft.com/office/drawing/2014/main" val="3865728519"/>
                    </a:ext>
                  </a:extLst>
                </a:gridCol>
                <a:gridCol w="552538">
                  <a:extLst>
                    <a:ext uri="{9D8B030D-6E8A-4147-A177-3AD203B41FA5}">
                      <a16:colId xmlns:a16="http://schemas.microsoft.com/office/drawing/2014/main" val="2308811097"/>
                    </a:ext>
                  </a:extLst>
                </a:gridCol>
                <a:gridCol w="552538">
                  <a:extLst>
                    <a:ext uri="{9D8B030D-6E8A-4147-A177-3AD203B41FA5}">
                      <a16:colId xmlns:a16="http://schemas.microsoft.com/office/drawing/2014/main" val="3848469901"/>
                    </a:ext>
                  </a:extLst>
                </a:gridCol>
                <a:gridCol w="552538">
                  <a:extLst>
                    <a:ext uri="{9D8B030D-6E8A-4147-A177-3AD203B41FA5}">
                      <a16:colId xmlns:a16="http://schemas.microsoft.com/office/drawing/2014/main" val="867541853"/>
                    </a:ext>
                  </a:extLst>
                </a:gridCol>
                <a:gridCol w="552538">
                  <a:extLst>
                    <a:ext uri="{9D8B030D-6E8A-4147-A177-3AD203B41FA5}">
                      <a16:colId xmlns:a16="http://schemas.microsoft.com/office/drawing/2014/main" val="581446731"/>
                    </a:ext>
                  </a:extLst>
                </a:gridCol>
                <a:gridCol w="552538">
                  <a:extLst>
                    <a:ext uri="{9D8B030D-6E8A-4147-A177-3AD203B41FA5}">
                      <a16:colId xmlns:a16="http://schemas.microsoft.com/office/drawing/2014/main" val="2095728350"/>
                    </a:ext>
                  </a:extLst>
                </a:gridCol>
                <a:gridCol w="552538">
                  <a:extLst>
                    <a:ext uri="{9D8B030D-6E8A-4147-A177-3AD203B41FA5}">
                      <a16:colId xmlns:a16="http://schemas.microsoft.com/office/drawing/2014/main" val="2320272726"/>
                    </a:ext>
                  </a:extLst>
                </a:gridCol>
                <a:gridCol w="552538">
                  <a:extLst>
                    <a:ext uri="{9D8B030D-6E8A-4147-A177-3AD203B41FA5}">
                      <a16:colId xmlns:a16="http://schemas.microsoft.com/office/drawing/2014/main" val="2780770775"/>
                    </a:ext>
                  </a:extLst>
                </a:gridCol>
              </a:tblGrid>
              <a:tr h="265419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rgbClr val="0432F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87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rgbClr val="0432F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82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rgbClr val="0432F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76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>
                          <a:solidFill>
                            <a:srgbClr val="0432F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71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>
                          <a:solidFill>
                            <a:srgbClr val="0432F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59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>
                          <a:solidFill>
                            <a:srgbClr val="0432F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40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>
                          <a:solidFill>
                            <a:srgbClr val="0432F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12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>
                          <a:solidFill>
                            <a:srgbClr val="0432F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1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>
                          <a:solidFill>
                            <a:srgbClr val="0432F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4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>
                          <a:solidFill>
                            <a:srgbClr val="0432F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rgbClr val="0432F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8136406"/>
                  </a:ext>
                </a:extLst>
              </a:tr>
              <a:tr h="265419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2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1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9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8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7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5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4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012626"/>
                  </a:ext>
                </a:extLst>
              </a:tr>
              <a:tr h="265419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rgbClr val="0B7D39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79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rgbClr val="0B7D39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77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rgbClr val="0B7D39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72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rgbClr val="0B7D39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60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rgbClr val="0B7D39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57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rgbClr val="0B7D39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3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rgbClr val="0B7D39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4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rgbClr val="0B7D39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0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rgbClr val="0B7D39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8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rgbClr val="0B7D39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rgbClr val="0B7D39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44503402"/>
                  </a:ext>
                </a:extLst>
              </a:tr>
              <a:tr h="265419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chemeClr val="accent2">
                              <a:lumMod val="50000"/>
                            </a:schemeClr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0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chemeClr val="accent2">
                              <a:lumMod val="50000"/>
                            </a:schemeClr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9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chemeClr val="accent2">
                              <a:lumMod val="50000"/>
                            </a:schemeClr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9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chemeClr val="accent2">
                              <a:lumMod val="50000"/>
                            </a:schemeClr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7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chemeClr val="accent2">
                              <a:lumMod val="50000"/>
                            </a:schemeClr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6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chemeClr val="accent2">
                              <a:lumMod val="50000"/>
                            </a:schemeClr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3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chemeClr val="accent2">
                              <a:lumMod val="50000"/>
                            </a:schemeClr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3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chemeClr val="accent2">
                              <a:lumMod val="50000"/>
                            </a:schemeClr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chemeClr val="accent2">
                              <a:lumMod val="50000"/>
                            </a:schemeClr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chemeClr val="accent2">
                              <a:lumMod val="50000"/>
                            </a:schemeClr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accent2">
                              <a:lumMod val="50000"/>
                            </a:schemeClr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200" b="0" i="0" u="none" strike="noStrike" dirty="0">
                        <a:solidFill>
                          <a:schemeClr val="accent2">
                            <a:lumMod val="50000"/>
                          </a:schemeClr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3893095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900550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2</TotalTime>
  <Words>151</Words>
  <Application>Microsoft Macintosh PowerPoint</Application>
  <PresentationFormat>ワイド画面</PresentationFormat>
  <Paragraphs>5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滋 井本</dc:creator>
  <cp:lastModifiedBy>井本滋</cp:lastModifiedBy>
  <cp:revision>21</cp:revision>
  <dcterms:created xsi:type="dcterms:W3CDTF">2024-01-16T00:09:53Z</dcterms:created>
  <dcterms:modified xsi:type="dcterms:W3CDTF">2025-05-24T07:05:51Z</dcterms:modified>
</cp:coreProperties>
</file>